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FECC45F-44EF-4661-8036-80B4E61AF037}" v="43" dt="2026-03-13T03:01:22.962"/>
    <p1510:client id="{2C5E4390-0523-4D35-A352-348CBC9E79B7}" v="70" dt="2026-03-13T06:47:10.88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96" d="100"/>
          <a:sy n="96" d="100"/>
        </p:scale>
        <p:origin x="1152" y="3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tsuo rika" userId="rd2gdoHKNJZOux31o6R/b6ryHYCYCY8GpdfoCXJNAVI=" providerId="None" clId="Web-{1FECC45F-44EF-4661-8036-80B4E61AF037}"/>
    <pc:docChg chg="modSld">
      <pc:chgData name="matsuo rika" userId="rd2gdoHKNJZOux31o6R/b6ryHYCYCY8GpdfoCXJNAVI=" providerId="None" clId="Web-{1FECC45F-44EF-4661-8036-80B4E61AF037}" dt="2026-03-13T03:01:19.243" v="12"/>
      <pc:docMkLst>
        <pc:docMk/>
      </pc:docMkLst>
      <pc:sldChg chg="modSp">
        <pc:chgData name="matsuo rika" userId="rd2gdoHKNJZOux31o6R/b6ryHYCYCY8GpdfoCXJNAVI=" providerId="None" clId="Web-{1FECC45F-44EF-4661-8036-80B4E61AF037}" dt="2026-03-13T03:01:19.243" v="12"/>
        <pc:sldMkLst>
          <pc:docMk/>
          <pc:sldMk cId="1991676640" sldId="256"/>
        </pc:sldMkLst>
        <pc:graphicFrameChg chg="mod modGraphic">
          <ac:chgData name="matsuo rika" userId="rd2gdoHKNJZOux31o6R/b6ryHYCYCY8GpdfoCXJNAVI=" providerId="None" clId="Web-{1FECC45F-44EF-4661-8036-80B4E61AF037}" dt="2026-03-13T03:01:19.243" v="12"/>
          <ac:graphicFrameMkLst>
            <pc:docMk/>
            <pc:sldMk cId="1991676640" sldId="256"/>
            <ac:graphicFrameMk id="5" creationId="{59C526BC-87E5-034E-8703-1B3A2B116075}"/>
          </ac:graphicFrameMkLst>
        </pc:graphicFrameChg>
      </pc:sldChg>
    </pc:docChg>
  </pc:docChgLst>
  <pc:docChgLst>
    <pc:chgData name="matsuo rika" userId="rd2gdoHKNJZOux31o6R/b6ryHYCYCY8GpdfoCXJNAVI=" providerId="None" clId="Web-{2C5E4390-0523-4D35-A352-348CBC9E79B7}"/>
    <pc:docChg chg="modSld">
      <pc:chgData name="matsuo rika" userId="rd2gdoHKNJZOux31o6R/b6ryHYCYCY8GpdfoCXJNAVI=" providerId="None" clId="Web-{2C5E4390-0523-4D35-A352-348CBC9E79B7}" dt="2026-03-13T06:47:10.884" v="60"/>
      <pc:docMkLst>
        <pc:docMk/>
      </pc:docMkLst>
      <pc:sldChg chg="modSp">
        <pc:chgData name="matsuo rika" userId="rd2gdoHKNJZOux31o6R/b6ryHYCYCY8GpdfoCXJNAVI=" providerId="None" clId="Web-{2C5E4390-0523-4D35-A352-348CBC9E79B7}" dt="2026-03-13T06:47:10.884" v="60"/>
        <pc:sldMkLst>
          <pc:docMk/>
          <pc:sldMk cId="1991676640" sldId="256"/>
        </pc:sldMkLst>
        <pc:graphicFrameChg chg="mod modGraphic">
          <ac:chgData name="matsuo rika" userId="rd2gdoHKNJZOux31o6R/b6ryHYCYCY8GpdfoCXJNAVI=" providerId="None" clId="Web-{2C5E4390-0523-4D35-A352-348CBC9E79B7}" dt="2026-03-13T06:47:10.884" v="60"/>
          <ac:graphicFrameMkLst>
            <pc:docMk/>
            <pc:sldMk cId="1991676640" sldId="256"/>
            <ac:graphicFrameMk id="5" creationId="{59C526BC-87E5-034E-8703-1B3A2B116075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9ACCC09-A998-41C5-BED6-7EB0284115E5}" type="datetimeFigureOut">
              <a:rPr kumimoji="1" lang="ja-JP" altLang="en-US" smtClean="0"/>
              <a:t>2026/3/1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BCEB5EC-BD99-4D69-9AF4-5609E4351F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16907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BCEB5EC-BD99-4D69-9AF4-5609E4351F7F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07411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C49A63F-A4F0-A5F9-2F69-9B7437265D3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7E47F09-9C64-A430-0695-8EB8E7A69C2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2215EBB-3E8D-16A0-487E-6BF4C07E99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AAA11E-75D8-45A2-B217-D9ED54F687C0}" type="datetimeFigureOut">
              <a:rPr kumimoji="1" lang="ja-JP" altLang="en-US" smtClean="0"/>
              <a:t>2026/3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7125A95-79CC-D47D-49F8-D4CE0163E8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28F96B9-372F-D616-0DA7-981C139E76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3C666-88DD-4E02-9D2E-0FA4985E04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93568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0AD8B15-86FA-4EE2-0038-279A456EF8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7E67028-921A-4E93-5AFF-88AB193B39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8803319-C294-F59D-3949-8FBB3CB729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AAA11E-75D8-45A2-B217-D9ED54F687C0}" type="datetimeFigureOut">
              <a:rPr kumimoji="1" lang="ja-JP" altLang="en-US" smtClean="0"/>
              <a:t>2026/3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6CF081F-CB3A-BC58-18BA-C7B9C1EE4B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23009A0-EA45-6DC7-4090-D6AB00DC33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3C666-88DD-4E02-9D2E-0FA4985E04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35625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175238A6-1C0B-47B8-C5D6-843CEFBA245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0DACF3A-A09A-69E0-45B6-EB18FEE84A9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FEB1A1A-7DF3-6063-E79E-531DB86BEC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AAA11E-75D8-45A2-B217-D9ED54F687C0}" type="datetimeFigureOut">
              <a:rPr kumimoji="1" lang="ja-JP" altLang="en-US" smtClean="0"/>
              <a:t>2026/3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644206A-FE9B-B8AA-B70D-5F78F5E161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6A1AEFC-C19F-DE0B-9C1D-02489F7C3E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3C666-88DD-4E02-9D2E-0FA4985E04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04814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C4D8ABA-675A-7CC5-6792-F306AECD2C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A6D33FC-C9C5-CFFE-CEE3-D6F15209171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A1F3A83-E8DF-9FDB-9DD6-6CF567C5B9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AAA11E-75D8-45A2-B217-D9ED54F687C0}" type="datetimeFigureOut">
              <a:rPr kumimoji="1" lang="ja-JP" altLang="en-US" smtClean="0"/>
              <a:t>2026/3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E799D5B-2B10-0FFB-302C-989DBAED65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3B645B8-B44F-71B0-AB00-A003713811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3C666-88DD-4E02-9D2E-0FA4985E04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62121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CE9D284-D697-1620-1C07-BA4FD26BE5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6DBF354-8055-4053-6122-6C5ADD3647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9A41208-4745-7735-B034-91CAE18C90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AAA11E-75D8-45A2-B217-D9ED54F687C0}" type="datetimeFigureOut">
              <a:rPr kumimoji="1" lang="ja-JP" altLang="en-US" smtClean="0"/>
              <a:t>2026/3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844318B-EE49-B2E7-1FA4-6B2185DDC4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94A1213-45AB-4918-942A-7BC4389555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3C666-88DD-4E02-9D2E-0FA4985E04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9882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5CB009D-003F-1BDE-3FC0-970F46AA6B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778F46B-8B8F-166A-DED3-5429BB4884B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C66F397-8500-5F08-1A51-7B7749E8960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363357D-D686-E56D-6C66-5994D44A4A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AAA11E-75D8-45A2-B217-D9ED54F687C0}" type="datetimeFigureOut">
              <a:rPr kumimoji="1" lang="ja-JP" altLang="en-US" smtClean="0"/>
              <a:t>2026/3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0C59697-C52F-C641-E42E-F0A7CABC8A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390BBCA-8679-CF45-5CBE-A2B6DB2F37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3C666-88DD-4E02-9D2E-0FA4985E04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7006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31CC22C-8C56-0C75-9BD3-FBC25F782D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D839F65-1750-B306-7907-AF3FA0A150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D483B60-F47E-2321-3B51-1F5ADB6C5EF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04BDFEC1-AB2A-E1B5-404D-6EE21A0AEAB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BF11F8D0-4218-EA2D-9882-1B91BDEB94A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4CA770E3-66C3-A2B1-82D1-BE37DB68AE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AAA11E-75D8-45A2-B217-D9ED54F687C0}" type="datetimeFigureOut">
              <a:rPr kumimoji="1" lang="ja-JP" altLang="en-US" smtClean="0"/>
              <a:t>2026/3/1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73E2767F-F3E8-3845-5339-1F6B92A4D0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F2C4C118-C61A-C93B-9DEA-D3BDBC2803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3C666-88DD-4E02-9D2E-0FA4985E04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36465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15C3B68-A6A1-0535-0E2A-F88C4A4E7C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B80A7EA3-B69A-F13D-A568-83626E1368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AAA11E-75D8-45A2-B217-D9ED54F687C0}" type="datetimeFigureOut">
              <a:rPr kumimoji="1" lang="ja-JP" altLang="en-US" smtClean="0"/>
              <a:t>2026/3/1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1F35D5B4-B50A-DACF-0320-3BB5BB7626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F094BBC0-032D-B233-7E0D-D812F5D84C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3C666-88DD-4E02-9D2E-0FA4985E04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09428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DC6C94D3-23D9-0635-BF6C-B8BD845A3D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AAA11E-75D8-45A2-B217-D9ED54F687C0}" type="datetimeFigureOut">
              <a:rPr kumimoji="1" lang="ja-JP" altLang="en-US" smtClean="0"/>
              <a:t>2026/3/1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4C892C3D-3A94-7DCA-7F59-757EB5FE45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027185FB-ECD7-C6CF-F2F9-70B31B0C47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3C666-88DD-4E02-9D2E-0FA4985E04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34977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8DC9C74-2569-47A9-93C7-A8A175FAC0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70D0EF1-E9B1-A037-5000-A5680319203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5EF8E6A-B816-3EBC-443F-AC6A77F265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64426DB-EFD6-2C92-879E-4AC4638BAE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AAA11E-75D8-45A2-B217-D9ED54F687C0}" type="datetimeFigureOut">
              <a:rPr kumimoji="1" lang="ja-JP" altLang="en-US" smtClean="0"/>
              <a:t>2026/3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F06FEAE-5360-BD97-883D-FE02DD77EC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C06A630-9975-301B-EDA0-16D568FE8C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3C666-88DD-4E02-9D2E-0FA4985E04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09770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135F1F6-21CA-BCA2-8CCD-6840348058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BB0F8E4F-A08B-4D7F-91D2-6EE833A3AC8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617C25D-54D0-2970-402A-91B06780A97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B9B40B2-5C24-E4DA-C72D-367AC851D7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AAA11E-75D8-45A2-B217-D9ED54F687C0}" type="datetimeFigureOut">
              <a:rPr kumimoji="1" lang="ja-JP" altLang="en-US" smtClean="0"/>
              <a:t>2026/3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C345939-E236-AC03-5DE4-B14034C43F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EE0A5DC-A5F6-634E-1C2B-6F203F8F4E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3C666-88DD-4E02-9D2E-0FA4985E04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20398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F8FDCD7-BDCF-56AD-F929-34067EA7CA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1FF048C-EA57-D364-150F-F5C3A41644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3F66E1E-EBF3-BA34-5DE2-F8B959D0ED8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DAAA11E-75D8-45A2-B217-D9ED54F687C0}" type="datetimeFigureOut">
              <a:rPr kumimoji="1" lang="ja-JP" altLang="en-US" smtClean="0"/>
              <a:t>2026/3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D1704F5-14AE-D2D9-5B80-FF4610278F6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495801F-E94E-211E-A661-ECBCE9BF491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C83C666-88DD-4E02-9D2E-0FA4985E04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49169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59C526BC-87E5-034E-8703-1B3A2B11607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35324564"/>
              </p:ext>
            </p:extLst>
          </p:nvPr>
        </p:nvGraphicFramePr>
        <p:xfrm>
          <a:off x="1143000" y="4657725"/>
          <a:ext cx="8455793" cy="1693545"/>
        </p:xfrm>
        <a:graphic>
          <a:graphicData uri="http://schemas.openxmlformats.org/drawingml/2006/table">
            <a:tbl>
              <a:tblPr firstRow="1" firstCol="1" bandRow="1"/>
              <a:tblGrid>
                <a:gridCol w="751440">
                  <a:extLst>
                    <a:ext uri="{9D8B030D-6E8A-4147-A177-3AD203B41FA5}">
                      <a16:colId xmlns:a16="http://schemas.microsoft.com/office/drawing/2014/main" val="3565234809"/>
                    </a:ext>
                  </a:extLst>
                </a:gridCol>
                <a:gridCol w="1407581">
                  <a:extLst>
                    <a:ext uri="{9D8B030D-6E8A-4147-A177-3AD203B41FA5}">
                      <a16:colId xmlns:a16="http://schemas.microsoft.com/office/drawing/2014/main" val="3484228289"/>
                    </a:ext>
                  </a:extLst>
                </a:gridCol>
                <a:gridCol w="1534583">
                  <a:extLst>
                    <a:ext uri="{9D8B030D-6E8A-4147-A177-3AD203B41FA5}">
                      <a16:colId xmlns:a16="http://schemas.microsoft.com/office/drawing/2014/main" val="2622530554"/>
                    </a:ext>
                  </a:extLst>
                </a:gridCol>
                <a:gridCol w="1088478">
                  <a:extLst>
                    <a:ext uri="{9D8B030D-6E8A-4147-A177-3AD203B41FA5}">
                      <a16:colId xmlns:a16="http://schemas.microsoft.com/office/drawing/2014/main" val="917399922"/>
                    </a:ext>
                  </a:extLst>
                </a:gridCol>
                <a:gridCol w="1419387">
                  <a:extLst>
                    <a:ext uri="{9D8B030D-6E8A-4147-A177-3AD203B41FA5}">
                      <a16:colId xmlns:a16="http://schemas.microsoft.com/office/drawing/2014/main" val="2813127725"/>
                    </a:ext>
                  </a:extLst>
                </a:gridCol>
                <a:gridCol w="2254324">
                  <a:extLst>
                    <a:ext uri="{9D8B030D-6E8A-4147-A177-3AD203B41FA5}">
                      <a16:colId xmlns:a16="http://schemas.microsoft.com/office/drawing/2014/main" val="469456959"/>
                    </a:ext>
                  </a:extLst>
                </a:gridCol>
              </a:tblGrid>
              <a:tr h="238125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endParaRPr lang="en-US" altLang="ja-JP" sz="1050" b="1" kern="100" dirty="0">
                        <a:effectLst/>
                        <a:latin typeface="Arial"/>
                        <a:ea typeface="游明朝"/>
                        <a:cs typeface="Arial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b="1" kern="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Yu Gothic"/>
                          <a:cs typeface="Arial"/>
                        </a:rPr>
                        <a:t>cDNA</a:t>
                      </a:r>
                      <a:endParaRPr lang="ja-JP" sz="1050" kern="100" dirty="0">
                        <a:effectLst/>
                        <a:latin typeface="Arial"/>
                        <a:ea typeface="Yu Gothic"/>
                        <a:cs typeface="Arial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1" i="0" u="none" strike="noStrike" kern="0" noProof="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Yu Gothic"/>
                          <a:cs typeface="Arial"/>
                        </a:rPr>
                        <a:t>VAF (%)</a:t>
                      </a:r>
                      <a:endParaRPr lang="en-US" sz="1100" b="0" i="0" u="none" strike="noStrike" kern="0" noProof="0" dirty="0">
                        <a:solidFill>
                          <a:srgbClr val="000000"/>
                        </a:solidFill>
                        <a:effectLst/>
                        <a:latin typeface="Arial"/>
                        <a:ea typeface="Yu Gothic"/>
                        <a:cs typeface="Arial"/>
                      </a:endParaRPr>
                    </a:p>
                    <a:p>
                      <a:pPr lvl="0" algn="ctr">
                        <a:buNone/>
                      </a:pPr>
                      <a:r>
                        <a:rPr lang="en-US" sz="1100" b="1" kern="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Yu Gothic"/>
                          <a:cs typeface="Arial"/>
                        </a:rPr>
                        <a:t>baseline (Before progression)</a:t>
                      </a:r>
                      <a:endParaRPr lang="ja-JP" sz="1050" kern="100">
                        <a:effectLst/>
                        <a:latin typeface="Arial"/>
                        <a:ea typeface="Yu Gothic"/>
                        <a:cs typeface="Arial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1" i="0" u="none" strike="noStrike" kern="0" noProof="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Yu Gothic"/>
                          <a:cs typeface="Arial"/>
                        </a:rPr>
                        <a:t>VAF (%)</a:t>
                      </a:r>
                      <a:endParaRPr lang="en-US" sz="1100" b="0" i="0" u="none" strike="noStrike" kern="0" noProof="0" dirty="0">
                        <a:solidFill>
                          <a:srgbClr val="000000"/>
                        </a:solidFill>
                        <a:effectLst/>
                        <a:latin typeface="Arial"/>
                        <a:ea typeface="Yu Gothic"/>
                        <a:cs typeface="Arial"/>
                      </a:endParaRPr>
                    </a:p>
                    <a:p>
                      <a:pPr lvl="0" algn="ctr">
                        <a:buNone/>
                      </a:pPr>
                      <a:r>
                        <a:rPr lang="en-US" sz="1100" b="1" kern="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Yu Gothic"/>
                          <a:cs typeface="Arial"/>
                        </a:rPr>
                        <a:t>post progression</a:t>
                      </a:r>
                      <a:endParaRPr lang="ja-JP" sz="1050" kern="100" dirty="0">
                        <a:effectLst/>
                        <a:latin typeface="Arial"/>
                        <a:ea typeface="Yu Gothic"/>
                        <a:cs typeface="Arial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b="1" kern="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Yu Gothic"/>
                          <a:cs typeface="Arial"/>
                        </a:rPr>
                        <a:t>germline/somatic</a:t>
                      </a:r>
                      <a:endParaRPr lang="ja-JP" sz="1050" kern="100" dirty="0">
                        <a:effectLst/>
                        <a:latin typeface="Arial"/>
                        <a:ea typeface="Yu Gothic"/>
                        <a:cs typeface="Arial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b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reversion mutation</a:t>
                      </a:r>
                      <a:endParaRPr lang="ja-JP" sz="105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67278503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i="1" kern="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Yu Gothic"/>
                          <a:cs typeface="Arial"/>
                        </a:rPr>
                        <a:t>BRCA2</a:t>
                      </a:r>
                      <a:endParaRPr lang="ja-JP" sz="1050" kern="100" dirty="0">
                        <a:effectLst/>
                        <a:latin typeface="Arial"/>
                        <a:ea typeface="Yu Gothic"/>
                        <a:cs typeface="Arial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Yu Gothic"/>
                          <a:cs typeface="Arial"/>
                        </a:rPr>
                        <a:t>c.1438_1439del</a:t>
                      </a:r>
                      <a:endParaRPr lang="ja-JP" sz="1050" kern="100" dirty="0">
                        <a:effectLst/>
                        <a:latin typeface="Arial"/>
                        <a:ea typeface="Yu Gothic"/>
                        <a:cs typeface="Arial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Yu Gothic"/>
                          <a:cs typeface="Arial"/>
                        </a:rPr>
                        <a:t>50.98</a:t>
                      </a:r>
                      <a:endParaRPr lang="ja-JP" sz="1050" kern="100" dirty="0">
                        <a:effectLst/>
                        <a:latin typeface="Arial"/>
                        <a:ea typeface="Yu Gothic"/>
                        <a:cs typeface="Arial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Yu Gothic"/>
                          <a:cs typeface="Arial"/>
                        </a:rPr>
                        <a:t>56.53</a:t>
                      </a:r>
                      <a:endParaRPr lang="ja-JP" sz="1050" kern="100" dirty="0">
                        <a:effectLst/>
                        <a:latin typeface="Arial"/>
                        <a:ea typeface="Yu Gothic"/>
                        <a:cs typeface="Arial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Yu Gothic"/>
                          <a:cs typeface="Arial"/>
                        </a:rPr>
                        <a:t>putative germline</a:t>
                      </a:r>
                      <a:endParaRPr lang="ja-JP" sz="1050" kern="100" dirty="0">
                        <a:effectLst/>
                        <a:latin typeface="Arial"/>
                        <a:ea typeface="Yu Gothic"/>
                        <a:cs typeface="Arial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buNone/>
                      </a:pPr>
                      <a:endParaRPr lang="ja-JP" sz="105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23121433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i="1" kern="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Yu Gothic"/>
                          <a:cs typeface="Arial"/>
                        </a:rPr>
                        <a:t>BRCA2</a:t>
                      </a:r>
                      <a:endParaRPr lang="ja-JP" sz="1050" kern="100" dirty="0">
                        <a:effectLst/>
                        <a:latin typeface="Arial"/>
                        <a:ea typeface="Yu Gothic"/>
                        <a:cs typeface="Arial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Yu Gothic"/>
                          <a:cs typeface="Arial"/>
                        </a:rPr>
                        <a:t>c.1403_1436del</a:t>
                      </a:r>
                      <a:endParaRPr lang="ja-JP" sz="105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Yu Gothic"/>
                          <a:cs typeface="Arial"/>
                        </a:rPr>
                        <a:t>0.25</a:t>
                      </a:r>
                      <a:endParaRPr lang="ja-JP" sz="1050" kern="100" dirty="0">
                        <a:effectLst/>
                        <a:latin typeface="Arial"/>
                        <a:ea typeface="Yu Gothic"/>
                        <a:cs typeface="Arial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16.55</a:t>
                      </a:r>
                      <a:endParaRPr lang="ja-JP" altLang="ja-JP" sz="105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Yu Gothic"/>
                          <a:cs typeface="Arial"/>
                        </a:rPr>
                        <a:t>putative somatic</a:t>
                      </a:r>
                      <a:endParaRPr lang="ja-JP" sz="1050" kern="100" dirty="0">
                        <a:effectLst/>
                        <a:latin typeface="Arial"/>
                        <a:ea typeface="Yu Gothic"/>
                        <a:cs typeface="Arial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putative reversion mutation</a:t>
                      </a:r>
                      <a:endParaRPr lang="ja-JP" sz="105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74360747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i="1" kern="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Yu Gothic"/>
                          <a:cs typeface="Arial"/>
                        </a:rPr>
                        <a:t>BRCA2</a:t>
                      </a:r>
                      <a:endParaRPr lang="ja-JP" sz="1050" kern="100" dirty="0">
                        <a:effectLst/>
                        <a:latin typeface="Arial"/>
                        <a:ea typeface="Yu Gothic"/>
                        <a:cs typeface="Arial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Yu Gothic"/>
                          <a:cs typeface="Arial"/>
                        </a:rPr>
                        <a:t>c.1408_1429del</a:t>
                      </a:r>
                      <a:endParaRPr lang="ja-JP" sz="1050" kern="100" dirty="0">
                        <a:effectLst/>
                        <a:latin typeface="Arial"/>
                        <a:ea typeface="Yu Gothic"/>
                        <a:cs typeface="Arial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0.36</a:t>
                      </a:r>
                      <a:endParaRPr lang="ja-JP" sz="105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Yu Gothic"/>
                          <a:cs typeface="Arial"/>
                        </a:rPr>
                        <a:t>1.71</a:t>
                      </a:r>
                      <a:endParaRPr lang="ja-JP" sz="1050" kern="100" dirty="0">
                        <a:effectLst/>
                        <a:latin typeface="Arial"/>
                        <a:ea typeface="Yu Gothic"/>
                        <a:cs typeface="Arial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Yu Gothic"/>
                          <a:cs typeface="Arial"/>
                        </a:rPr>
                        <a:t>putative somatic</a:t>
                      </a:r>
                      <a:endParaRPr lang="ja-JP" sz="1050" kern="100" dirty="0">
                        <a:effectLst/>
                        <a:latin typeface="Arial"/>
                        <a:ea typeface="Yu Gothic"/>
                        <a:cs typeface="Arial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putative reversion mutation</a:t>
                      </a:r>
                      <a:endParaRPr lang="ja-JP" sz="105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39178399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i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BRCA2</a:t>
                      </a:r>
                      <a:endParaRPr lang="ja-JP" sz="105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c.1492_1549del</a:t>
                      </a:r>
                      <a:endParaRPr lang="ja-JP" sz="105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Yu Gothic"/>
                          <a:cs typeface="Arial"/>
                        </a:rPr>
                        <a:t>0</a:t>
                      </a:r>
                      <a:endParaRPr lang="ja-JP" sz="1050" kern="100" dirty="0">
                        <a:effectLst/>
                        <a:latin typeface="Arial"/>
                        <a:ea typeface="Yu Gothic"/>
                        <a:cs typeface="Arial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2.72</a:t>
                      </a:r>
                      <a:endParaRPr lang="ja-JP" sz="105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Yu Gothic"/>
                          <a:cs typeface="Arial"/>
                        </a:rPr>
                        <a:t>putative somatic</a:t>
                      </a:r>
                      <a:endParaRPr lang="ja-JP" sz="1050" kern="100" dirty="0">
                        <a:effectLst/>
                        <a:latin typeface="Arial"/>
                        <a:ea typeface="Yu Gothic"/>
                        <a:cs typeface="Arial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putative reversion mutation</a:t>
                      </a:r>
                      <a:endParaRPr lang="ja-JP" sz="105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67916615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i="1" kern="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Yu Gothic"/>
                          <a:cs typeface="Arial"/>
                        </a:rPr>
                        <a:t>BRCA2</a:t>
                      </a:r>
                      <a:endParaRPr lang="ja-JP" sz="1050" kern="100" dirty="0">
                        <a:effectLst/>
                        <a:latin typeface="Arial"/>
                        <a:ea typeface="Yu Gothic"/>
                        <a:cs typeface="Arial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Yu Gothic"/>
                          <a:cs typeface="Arial"/>
                        </a:rPr>
                        <a:t>c.1507_1525del</a:t>
                      </a:r>
                      <a:endParaRPr lang="ja-JP" sz="1050" kern="100" dirty="0">
                        <a:effectLst/>
                        <a:latin typeface="Arial"/>
                        <a:ea typeface="Yu Gothic"/>
                        <a:cs typeface="Arial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Yu Gothic"/>
                          <a:cs typeface="Arial"/>
                        </a:rPr>
                        <a:t>0.1</a:t>
                      </a:r>
                      <a:endParaRPr lang="ja-JP" sz="1050" kern="100" dirty="0">
                        <a:effectLst/>
                        <a:latin typeface="Arial"/>
                        <a:ea typeface="Yu Gothic"/>
                        <a:cs typeface="Arial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Yu Gothic"/>
                          <a:cs typeface="Arial"/>
                        </a:rPr>
                        <a:t>0.14</a:t>
                      </a:r>
                      <a:endParaRPr lang="ja-JP" sz="1050" kern="100" dirty="0">
                        <a:effectLst/>
                        <a:latin typeface="Arial"/>
                        <a:ea typeface="Yu Gothic"/>
                        <a:cs typeface="Arial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Yu Gothic"/>
                          <a:cs typeface="Arial"/>
                        </a:rPr>
                        <a:t>putative somatic</a:t>
                      </a:r>
                      <a:endParaRPr lang="ja-JP" sz="1050" kern="100" dirty="0">
                        <a:effectLst/>
                        <a:latin typeface="Arial"/>
                        <a:ea typeface="Yu Gothic"/>
                        <a:cs typeface="Arial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putative reversion mutation</a:t>
                      </a:r>
                      <a:endParaRPr lang="ja-JP" sz="105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37190866"/>
                  </a:ext>
                </a:extLst>
              </a:tr>
            </a:tbl>
          </a:graphicData>
        </a:graphic>
      </p:graphicFrame>
      <p:sp>
        <p:nvSpPr>
          <p:cNvPr id="6" name="Rectangle 1">
            <a:extLst>
              <a:ext uri="{FF2B5EF4-FFF2-40B4-BE49-F238E27FC236}">
                <a16:creationId xmlns:a16="http://schemas.microsoft.com/office/drawing/2014/main" id="{594857F5-6B18-0A72-C6B7-5AE90064BBA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76388" y="2784475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ja-JP" altLang="en-US"/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A054A4A4-685E-12A1-9798-69898C798EC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76388" y="392965"/>
            <a:ext cx="7194933" cy="36920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916766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1</TotalTime>
  <Words>70</Words>
  <Application>Microsoft Office PowerPoint</Application>
  <PresentationFormat>ワイド画面</PresentationFormat>
  <Paragraphs>37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游明朝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itomi Sakai</dc:creator>
  <cp:lastModifiedBy>Hitomi Sakai</cp:lastModifiedBy>
  <cp:revision>33</cp:revision>
  <dcterms:created xsi:type="dcterms:W3CDTF">2026-03-11T10:27:27Z</dcterms:created>
  <dcterms:modified xsi:type="dcterms:W3CDTF">2026-03-13T08:44:29Z</dcterms:modified>
</cp:coreProperties>
</file>